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9.png" ContentType="image/png"/>
  <Override PartName="/ppt/media/image13.png" ContentType="image/png"/>
  <Override PartName="/ppt/media/image11.jpeg" ContentType="image/jpe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59862-7E61-44E5-998B-EEC34B643E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1E957-4E37-4C79-BD0A-75A3A94DF1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FEA66-483C-4AD2-A3FC-03F96D830D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B6304-A7A9-49D9-BE3D-382CBC5CB0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10589-EDF1-461C-97E9-E4C0764480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D059A-39DA-472B-80FB-78C0EB77A9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F11E1-7235-4319-98C8-3D52AC8340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3BDBD-2860-4CCD-B211-EF9A32B411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6CF65-347A-474F-BD75-EBF896A569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6FBB3-797F-44FB-BACE-F482A57480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6F5CA-31A5-434E-9B10-8EF3E19AE9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4A814-B921-40B3-9EB9-372F4BFED6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1CBA7F-49F6-4DC5-AAA7-96D66B4C15F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صورة 4" descr="صورة تحتوي على فضي, إغلاق&#10;&#10;تم إنشاء الوصف تلقائياً"/>
          <p:cNvPicPr/>
          <p:nvPr/>
        </p:nvPicPr>
        <p:blipFill>
          <a:blip r:embed="rId1">
            <a:lum bright="-30000"/>
          </a:blip>
          <a:srcRect l="12604" t="8972" r="0" b="5459"/>
          <a:stretch/>
        </p:blipFill>
        <p:spPr>
          <a:xfrm>
            <a:off x="2286000" y="457200"/>
            <a:ext cx="4275000" cy="3836880"/>
          </a:xfrm>
          <a:prstGeom prst="rect">
            <a:avLst/>
          </a:prstGeom>
          <a:ln w="0">
            <a:noFill/>
          </a:ln>
        </p:spPr>
      </p:pic>
      <p:sp>
        <p:nvSpPr>
          <p:cNvPr id="42" name="Content Placeholder 2"/>
          <p:cNvSpPr/>
          <p:nvPr/>
        </p:nvSpPr>
        <p:spPr>
          <a:xfrm>
            <a:off x="609480" y="4495680"/>
            <a:ext cx="83059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: Antimicrobial sensitivity of clinical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teritidis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olate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isolate was  resistant to ampicillin (AM), ampicillin/sulbactam (SAM), ceftriaxone (CRO), cefuroxime (CXM), chloramphenicol,  ofloxaci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 OFX), streptomycin (S) and gentamycin (CN), meanwhile it was sensitive to imipene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عنصر نائب للمحتوى 4" descr=""/>
          <p:cNvPicPr/>
          <p:nvPr/>
        </p:nvPicPr>
        <p:blipFill>
          <a:blip r:embed="rId1"/>
          <a:srcRect l="32016" t="15151" r="32963" b="19186"/>
          <a:stretch/>
        </p:blipFill>
        <p:spPr>
          <a:xfrm>
            <a:off x="4921200" y="316080"/>
            <a:ext cx="3917880" cy="4130640"/>
          </a:xfrm>
          <a:prstGeom prst="rect">
            <a:avLst/>
          </a:prstGeom>
          <a:ln w="0">
            <a:noFill/>
          </a:ln>
        </p:spPr>
      </p:pic>
      <p:pic>
        <p:nvPicPr>
          <p:cNvPr id="44" name="صورة 6" descr=""/>
          <p:cNvPicPr/>
          <p:nvPr/>
        </p:nvPicPr>
        <p:blipFill>
          <a:blip r:embed="rId2">
            <a:lum contrast="30000"/>
          </a:blip>
          <a:srcRect l="31668" t="18487" r="31668" b="8498"/>
          <a:stretch/>
        </p:blipFill>
        <p:spPr>
          <a:xfrm>
            <a:off x="731880" y="326880"/>
            <a:ext cx="3689280" cy="4131000"/>
          </a:xfrm>
          <a:prstGeom prst="rect">
            <a:avLst/>
          </a:prstGeom>
          <a:ln w="0">
            <a:noFill/>
          </a:ln>
        </p:spPr>
      </p:pic>
      <p:sp>
        <p:nvSpPr>
          <p:cNvPr id="45" name="TextBox 6"/>
          <p:cNvSpPr/>
          <p:nvPr/>
        </p:nvSpPr>
        <p:spPr>
          <a:xfrm>
            <a:off x="304920" y="4876920"/>
            <a:ext cx="8686800" cy="11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2: S. Enteritidis CFU cultivated from broiler livers onto Rapaport agar medium at 12 h post challenge. The CFU/gm was observed in the liver of CPN-NS non-supplemented broilers (right) compared to complete clearance after 7 days in challenged chicks with SE (left) 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صورة 8" descr=""/>
          <p:cNvPicPr/>
          <p:nvPr/>
        </p:nvPicPr>
        <p:blipFill>
          <a:blip r:embed="rId1"/>
          <a:srcRect l="31671" t="14435" r="31671" b="14435"/>
          <a:stretch/>
        </p:blipFill>
        <p:spPr>
          <a:xfrm>
            <a:off x="5062680" y="392040"/>
            <a:ext cx="3886200" cy="4240440"/>
          </a:xfrm>
          <a:prstGeom prst="rect">
            <a:avLst/>
          </a:prstGeom>
          <a:ln w="0">
            <a:noFill/>
          </a:ln>
        </p:spPr>
      </p:pic>
      <p:pic>
        <p:nvPicPr>
          <p:cNvPr id="47" name="صورة 10" descr=""/>
          <p:cNvPicPr/>
          <p:nvPr/>
        </p:nvPicPr>
        <p:blipFill>
          <a:blip r:embed="rId2"/>
          <a:srcRect l="35834" t="22972" r="38335" b="32215"/>
          <a:stretch/>
        </p:blipFill>
        <p:spPr>
          <a:xfrm>
            <a:off x="223920" y="392040"/>
            <a:ext cx="4348080" cy="4240440"/>
          </a:xfrm>
          <a:prstGeom prst="rect">
            <a:avLst/>
          </a:prstGeom>
          <a:ln w="0">
            <a:noFill/>
          </a:ln>
        </p:spPr>
      </p:pic>
      <p:sp>
        <p:nvSpPr>
          <p:cNvPr id="48" name="TextBox 4"/>
          <p:cNvSpPr/>
          <p:nvPr/>
        </p:nvSpPr>
        <p:spPr>
          <a:xfrm>
            <a:off x="152280" y="5029200"/>
            <a:ext cx="8686800" cy="11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3: S. Enteritidis CFU cultivated from broiler fecal droppings onto Rapaport agar medium at 7 days post challenge. The CFU/gm was observed in the liver of CPN-NS non-supplemented broilers (right) compared to complete clearance (left) after 7 days in challenged chicks with SE (left) 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7" descr=""/>
          <p:cNvPicPr/>
          <p:nvPr/>
        </p:nvPicPr>
        <p:blipFill>
          <a:blip r:embed="rId1"/>
          <a:stretch/>
        </p:blipFill>
        <p:spPr>
          <a:xfrm>
            <a:off x="2438280" y="304920"/>
            <a:ext cx="3105360" cy="3213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"/>
          <p:cNvPicPr/>
          <p:nvPr/>
        </p:nvPicPr>
        <p:blipFill>
          <a:blip r:embed="rId2"/>
          <a:stretch/>
        </p:blipFill>
        <p:spPr>
          <a:xfrm>
            <a:off x="5867280" y="304920"/>
            <a:ext cx="3025800" cy="3213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"/>
          <p:cNvPicPr/>
          <p:nvPr/>
        </p:nvPicPr>
        <p:blipFill>
          <a:blip r:embed="rId3"/>
          <a:srcRect l="0" t="0" r="0" b="12971"/>
          <a:stretch/>
        </p:blipFill>
        <p:spPr>
          <a:xfrm>
            <a:off x="2394000" y="3719520"/>
            <a:ext cx="3173400" cy="2986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" descr=""/>
          <p:cNvPicPr/>
          <p:nvPr/>
        </p:nvPicPr>
        <p:blipFill>
          <a:blip r:embed="rId4"/>
          <a:stretch/>
        </p:blipFill>
        <p:spPr>
          <a:xfrm>
            <a:off x="5900760" y="3719520"/>
            <a:ext cx="2998800" cy="3092400"/>
          </a:xfrm>
          <a:prstGeom prst="rect">
            <a:avLst/>
          </a:prstGeom>
          <a:ln w="0">
            <a:noFill/>
          </a:ln>
        </p:spPr>
      </p:pic>
      <p:sp>
        <p:nvSpPr>
          <p:cNvPr id="53" name="TextBox 8"/>
          <p:cNvSpPr/>
          <p:nvPr/>
        </p:nvSpPr>
        <p:spPr>
          <a:xfrm>
            <a:off x="106200" y="457200"/>
            <a:ext cx="2264040" cy="612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. 4: Gross image of the intestine and livers of broilers supplemented with CNP-NS and non-supplemented after S. Enteritidis challenge. Non supplemented broiler viscera showed congested blood vessels (left) post-bacterial challenge compared to no congestion in CNP-NS supplemented  (right). bacterial challenge posted, congested liver (left) versus CNP-NS protected liver (right).   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C:\Users\Riad soft\Downloads\IMG-20230130-WA0074.jpg"/>
          <p:cNvPicPr/>
          <p:nvPr/>
        </p:nvPicPr>
        <p:blipFill>
          <a:blip r:embed="rId1"/>
          <a:stretch/>
        </p:blipFill>
        <p:spPr>
          <a:xfrm>
            <a:off x="228600" y="533520"/>
            <a:ext cx="3936960" cy="29527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" descr="C:\Users\Riad soft\Downloads\IMG-20230130-WA0076.jpg"/>
          <p:cNvPicPr/>
          <p:nvPr/>
        </p:nvPicPr>
        <p:blipFill>
          <a:blip r:embed="rId2"/>
          <a:srcRect l="29260" t="62294" r="0" b="13332"/>
          <a:stretch/>
        </p:blipFill>
        <p:spPr>
          <a:xfrm>
            <a:off x="4419720" y="533520"/>
            <a:ext cx="3638520" cy="2971800"/>
          </a:xfrm>
          <a:prstGeom prst="rect">
            <a:avLst/>
          </a:prstGeom>
          <a:ln w="0">
            <a:noFill/>
          </a:ln>
        </p:spPr>
      </p:pic>
      <p:sp>
        <p:nvSpPr>
          <p:cNvPr id="56" name="مربع نص 5"/>
          <p:cNvSpPr/>
          <p:nvPr/>
        </p:nvSpPr>
        <p:spPr>
          <a:xfrm>
            <a:off x="609480" y="3962520"/>
            <a:ext cx="7315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5: Clinical symptoms of challenged chick showing dropping wings  and diarrhe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مربع نص 2"/>
          <p:cNvSpPr/>
          <p:nvPr/>
        </p:nvSpPr>
        <p:spPr>
          <a:xfrm>
            <a:off x="685800" y="5891040"/>
            <a:ext cx="5791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S-CNP: the nanoparticles supplemented chick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: the nanoparticles non supplemented and SE challenged chick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: nanoparticles non supplemented and  mock infected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1905120" y="152280"/>
          <a:ext cx="5322600" cy="984240"/>
        </p:xfrm>
        <a:graphic>
          <a:graphicData uri="http://schemas.openxmlformats.org/drawingml/2006/table">
            <a:tbl>
              <a:tblPr/>
              <a:tblGrid>
                <a:gridCol w="1906560"/>
                <a:gridCol w="1708200"/>
                <a:gridCol w="1707840"/>
              </a:tblGrid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Grou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verage feed intak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verage Body Weight (g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208080"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-CN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109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58560"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S-CNP non-supplemented and SE challeng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84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209520"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8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 rtl="1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11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  <p:pic>
        <p:nvPicPr>
          <p:cNvPr id="59" name="Picture 2" descr=""/>
          <p:cNvPicPr/>
          <p:nvPr/>
        </p:nvPicPr>
        <p:blipFill>
          <a:blip r:embed="rId1"/>
          <a:stretch/>
        </p:blipFill>
        <p:spPr>
          <a:xfrm>
            <a:off x="2722680" y="1219320"/>
            <a:ext cx="3698640" cy="1931760"/>
          </a:xfrm>
          <a:prstGeom prst="rect">
            <a:avLst/>
          </a:prstGeom>
          <a:ln w="0">
            <a:noFill/>
          </a:ln>
        </p:spPr>
      </p:pic>
      <p:pic>
        <p:nvPicPr>
          <p:cNvPr id="60" name="Chart 3" descr=""/>
          <p:cNvPicPr/>
          <p:nvPr/>
        </p:nvPicPr>
        <p:blipFill>
          <a:blip r:embed="rId2"/>
          <a:stretch/>
        </p:blipFill>
        <p:spPr>
          <a:xfrm>
            <a:off x="2712960" y="3249720"/>
            <a:ext cx="3687840" cy="1938240"/>
          </a:xfrm>
          <a:prstGeom prst="rect">
            <a:avLst/>
          </a:prstGeom>
          <a:ln w="0">
            <a:noFill/>
          </a:ln>
        </p:spPr>
      </p:pic>
      <p:sp>
        <p:nvSpPr>
          <p:cNvPr id="61" name="مربع نص 6"/>
          <p:cNvSpPr/>
          <p:nvPr/>
        </p:nvSpPr>
        <p:spPr>
          <a:xfrm>
            <a:off x="304920" y="5181480"/>
            <a:ext cx="7902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6: feed intake and body gain in CNP-NS supplemented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d non-supplemented chick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مجموعة 1"/>
          <p:cNvGrpSpPr/>
          <p:nvPr/>
        </p:nvGrpSpPr>
        <p:grpSpPr>
          <a:xfrm>
            <a:off x="152280" y="376200"/>
            <a:ext cx="8763120" cy="5186520"/>
            <a:chOff x="152280" y="376200"/>
            <a:chExt cx="8763120" cy="5186520"/>
          </a:xfrm>
        </p:grpSpPr>
        <p:pic>
          <p:nvPicPr>
            <p:cNvPr id="63" name="Picture 4" descr=""/>
            <p:cNvPicPr/>
            <p:nvPr/>
          </p:nvPicPr>
          <p:blipFill>
            <a:blip r:embed="rId1"/>
            <a:stretch/>
          </p:blipFill>
          <p:spPr>
            <a:xfrm>
              <a:off x="186120" y="376200"/>
              <a:ext cx="4388760" cy="2630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2" descr=""/>
            <p:cNvPicPr/>
            <p:nvPr/>
          </p:nvPicPr>
          <p:blipFill>
            <a:blip r:embed="rId2"/>
            <a:stretch/>
          </p:blipFill>
          <p:spPr>
            <a:xfrm>
              <a:off x="5049360" y="376200"/>
              <a:ext cx="3855600" cy="253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4" descr=""/>
            <p:cNvPicPr/>
            <p:nvPr/>
          </p:nvPicPr>
          <p:blipFill>
            <a:blip r:embed="rId3"/>
            <a:stretch/>
          </p:blipFill>
          <p:spPr>
            <a:xfrm>
              <a:off x="5049360" y="3143520"/>
              <a:ext cx="3866040" cy="2359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4" descr=""/>
            <p:cNvPicPr/>
            <p:nvPr/>
          </p:nvPicPr>
          <p:blipFill>
            <a:blip r:embed="rId4"/>
            <a:srcRect l="0" t="0" r="4846" b="0"/>
            <a:stretch/>
          </p:blipFill>
          <p:spPr>
            <a:xfrm>
              <a:off x="152280" y="3087000"/>
              <a:ext cx="4453560" cy="2475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7" name="مربع نص 6"/>
          <p:cNvSpPr/>
          <p:nvPr/>
        </p:nvSpPr>
        <p:spPr>
          <a:xfrm>
            <a:off x="609480" y="5943600"/>
            <a:ext cx="769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7: Some representative curves of the qRT-P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"/>
          <p:cNvPicPr/>
          <p:nvPr/>
        </p:nvPicPr>
        <p:blipFill>
          <a:blip r:embed="rId1"/>
          <a:srcRect l="3452" t="2353" r="-3440" b="0"/>
          <a:stretch/>
        </p:blipFill>
        <p:spPr>
          <a:xfrm>
            <a:off x="2928960" y="1643040"/>
            <a:ext cx="4286160" cy="3075120"/>
          </a:xfrm>
          <a:prstGeom prst="rect">
            <a:avLst/>
          </a:prstGeom>
          <a:ln w="0">
            <a:noFill/>
          </a:ln>
        </p:spPr>
      </p:pic>
      <p:sp>
        <p:nvSpPr>
          <p:cNvPr id="69" name="مربع نص 4"/>
          <p:cNvSpPr/>
          <p:nvPr/>
        </p:nvSpPr>
        <p:spPr>
          <a:xfrm>
            <a:off x="3071880" y="1285920"/>
            <a:ext cx="364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                                   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مربع نص 5"/>
          <p:cNvSpPr/>
          <p:nvPr/>
        </p:nvSpPr>
        <p:spPr>
          <a:xfrm>
            <a:off x="214200" y="4857840"/>
            <a:ext cx="8701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8: Bacterial colony phenotype after incubating SE with sera from non-supplemented CNP-NS chicks (A) and CNP-NS-supplemented chicks 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Following SE incubation with sera , many circularly elevated and pasty colonies were observed in CNP-NS non-supplemented chicks (A), whereas only a few pin-point colonies (B) were observed in CNP-NS supplemented chick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Dr_Adel</dc:creator>
  <dc:description/>
  <dc:language>en-US</dc:language>
  <cp:lastModifiedBy>Riad soft</cp:lastModifiedBy>
  <dcterms:modified xsi:type="dcterms:W3CDTF">2023-01-31T11:11:31Z</dcterms:modified>
  <cp:revision>554</cp:revision>
  <dc:subject/>
  <dc:title>Slide 1</dc:title>
</cp:coreProperties>
</file>